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B247FD-FBDC-44DA-977C-E135096122C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B1AD94-17E5-41F6-9FDA-D7E9DD858FB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160606-3DCF-476E-9905-E17961AC530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F8BC88-5269-425D-969E-47B41AD754B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62A0CB-78FF-4DC0-B375-21E3618C7B8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440A21-B824-4C21-8DDF-A6EF751A5F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7D178C-FA74-4E7B-BFB4-7F6690F778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2A1989-A5AE-4FD4-8D33-3B099DB7BF0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497342-6767-48D5-ABE0-ABB7396353F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A421B1-B329-4F65-A661-D50ED5A0EC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F33E87-9B81-4D63-AE9D-6D39469A90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0A3E7D-9E69-4AF5-B7D4-03DA2AE4DA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2353005-D131-40AA-815E-D8B0406DFD0F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5"/>
          <p:cNvSpPr/>
          <p:nvPr/>
        </p:nvSpPr>
        <p:spPr>
          <a:xfrm>
            <a:off x="361800" y="3637080"/>
            <a:ext cx="61232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PGSLSGTEQAEMKMAVISEHLGLSWAELARELQFSVEDINRIRVENPNSLLEQSVALLNLWVIREGQNANMENLYTALQSIDRGEIVNMLEGS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Right Brace 7"/>
          <p:cNvSpPr/>
          <p:nvPr/>
        </p:nvSpPr>
        <p:spPr>
          <a:xfrm rot="16200000">
            <a:off x="1266120" y="-127800"/>
            <a:ext cx="384120" cy="2538360"/>
          </a:xfrm>
          <a:custGeom>
            <a:avLst/>
            <a:gdLst>
              <a:gd name="textAreaLeft" fmla="*/ 0 w 384120"/>
              <a:gd name="textAreaRight" fmla="*/ 138600 w 384120"/>
              <a:gd name="textAreaTop" fmla="*/ 9720 h 2538360"/>
              <a:gd name="textAreaBottom" fmla="*/ 2528640 h 25383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36"/>
                  <a:pt x="10800" y="272"/>
                </a:cubicBezTo>
                <a:lnTo>
                  <a:pt x="10800" y="10528"/>
                </a:lnTo>
                <a:cubicBezTo>
                  <a:pt x="10800" y="10664"/>
                  <a:pt x="16200" y="10800"/>
                  <a:pt x="21600" y="10800"/>
                </a:cubicBezTo>
                <a:cubicBezTo>
                  <a:pt x="16200" y="10800"/>
                  <a:pt x="10800" y="10936"/>
                  <a:pt x="10800" y="11072"/>
                </a:cubicBezTo>
                <a:lnTo>
                  <a:pt x="10800" y="21328"/>
                </a:lnTo>
                <a:cubicBezTo>
                  <a:pt x="10800" y="21464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Rectangle 9"/>
          <p:cNvSpPr/>
          <p:nvPr/>
        </p:nvSpPr>
        <p:spPr>
          <a:xfrm>
            <a:off x="485640" y="615960"/>
            <a:ext cx="2571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embrane binding doma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Right Brace 10"/>
          <p:cNvSpPr/>
          <p:nvPr/>
        </p:nvSpPr>
        <p:spPr>
          <a:xfrm rot="16200000">
            <a:off x="3596400" y="79560"/>
            <a:ext cx="384120" cy="2122560"/>
          </a:xfrm>
          <a:custGeom>
            <a:avLst/>
            <a:gdLst>
              <a:gd name="textAreaLeft" fmla="*/ 0 w 384120"/>
              <a:gd name="textAreaRight" fmla="*/ 138600 w 384120"/>
              <a:gd name="textAreaTop" fmla="*/ 9720 h 2122560"/>
              <a:gd name="textAreaBottom" fmla="*/ 2112840 h 21225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63"/>
                  <a:pt x="10800" y="326"/>
                </a:cubicBezTo>
                <a:lnTo>
                  <a:pt x="10800" y="10474"/>
                </a:lnTo>
                <a:cubicBezTo>
                  <a:pt x="10800" y="10637"/>
                  <a:pt x="16200" y="10800"/>
                  <a:pt x="21600" y="10800"/>
                </a:cubicBezTo>
                <a:cubicBezTo>
                  <a:pt x="16200" y="10800"/>
                  <a:pt x="10800" y="10963"/>
                  <a:pt x="10800" y="11126"/>
                </a:cubicBezTo>
                <a:lnTo>
                  <a:pt x="10800" y="21274"/>
                </a:lnTo>
                <a:cubicBezTo>
                  <a:pt x="10800" y="21437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Right Brace 11"/>
          <p:cNvSpPr/>
          <p:nvPr/>
        </p:nvSpPr>
        <p:spPr>
          <a:xfrm rot="16200000">
            <a:off x="5486400" y="312480"/>
            <a:ext cx="384120" cy="1657080"/>
          </a:xfrm>
          <a:custGeom>
            <a:avLst/>
            <a:gdLst>
              <a:gd name="textAreaLeft" fmla="*/ 0 w 384120"/>
              <a:gd name="textAreaRight" fmla="*/ 138600 w 384120"/>
              <a:gd name="textAreaTop" fmla="*/ 9720 h 1657080"/>
              <a:gd name="textAreaBottom" fmla="*/ 1647360 h 16570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209"/>
                  <a:pt x="10800" y="417"/>
                </a:cubicBezTo>
                <a:lnTo>
                  <a:pt x="10800" y="10383"/>
                </a:lnTo>
                <a:cubicBezTo>
                  <a:pt x="10800" y="10592"/>
                  <a:pt x="16200" y="10800"/>
                  <a:pt x="21600" y="10800"/>
                </a:cubicBezTo>
                <a:cubicBezTo>
                  <a:pt x="16200" y="10800"/>
                  <a:pt x="10800" y="11009"/>
                  <a:pt x="10800" y="11217"/>
                </a:cubicBezTo>
                <a:lnTo>
                  <a:pt x="10800" y="21183"/>
                </a:lnTo>
                <a:cubicBezTo>
                  <a:pt x="10800" y="21392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Rectangle 12"/>
          <p:cNvSpPr/>
          <p:nvPr/>
        </p:nvSpPr>
        <p:spPr>
          <a:xfrm>
            <a:off x="3017880" y="615960"/>
            <a:ext cx="2571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pectrin binding doma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Rectangle 13"/>
          <p:cNvSpPr/>
          <p:nvPr/>
        </p:nvSpPr>
        <p:spPr>
          <a:xfrm>
            <a:off x="5013360" y="619200"/>
            <a:ext cx="1676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gulatory doma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Rectangle 21"/>
          <p:cNvSpPr/>
          <p:nvPr/>
        </p:nvSpPr>
        <p:spPr>
          <a:xfrm>
            <a:off x="4627440" y="2254320"/>
            <a:ext cx="10162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ath domain: 1393 - 148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Picture 2" descr="C:\Users\ah415\Desktop\ANK1 domains.png"/>
          <p:cNvPicPr/>
          <p:nvPr/>
        </p:nvPicPr>
        <p:blipFill>
          <a:blip r:embed="rId1"/>
          <a:stretch/>
        </p:blipFill>
        <p:spPr>
          <a:xfrm>
            <a:off x="179280" y="1333440"/>
            <a:ext cx="6489720" cy="809640"/>
          </a:xfrm>
          <a:prstGeom prst="rect">
            <a:avLst/>
          </a:prstGeom>
          <a:ln w="0">
            <a:noFill/>
          </a:ln>
        </p:spPr>
      </p:pic>
      <p:sp>
        <p:nvSpPr>
          <p:cNvPr id="50" name="Straight Connector 3"/>
          <p:cNvSpPr/>
          <p:nvPr/>
        </p:nvSpPr>
        <p:spPr>
          <a:xfrm flipH="1">
            <a:off x="453600" y="1887480"/>
            <a:ext cx="4395960" cy="1749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Straight Connector 4"/>
          <p:cNvSpPr/>
          <p:nvPr/>
        </p:nvSpPr>
        <p:spPr>
          <a:xfrm>
            <a:off x="5187960" y="1897200"/>
            <a:ext cx="1103400" cy="1739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3411"/>
          <p:cNvSpPr/>
          <p:nvPr/>
        </p:nvSpPr>
        <p:spPr>
          <a:xfrm>
            <a:off x="6480" y="-15840"/>
            <a:ext cx="2270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S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7"/>
          <p:cNvSpPr/>
          <p:nvPr/>
        </p:nvSpPr>
        <p:spPr>
          <a:xfrm>
            <a:off x="247680" y="326880"/>
            <a:ext cx="287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18"/>
          <p:cNvSpPr/>
          <p:nvPr/>
        </p:nvSpPr>
        <p:spPr>
          <a:xfrm>
            <a:off x="260280" y="4222800"/>
            <a:ext cx="289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19"/>
          <p:cNvSpPr/>
          <p:nvPr/>
        </p:nvSpPr>
        <p:spPr>
          <a:xfrm>
            <a:off x="260280" y="6804000"/>
            <a:ext cx="289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6" name="Picture 2" descr=""/>
          <p:cNvPicPr/>
          <p:nvPr/>
        </p:nvPicPr>
        <p:blipFill>
          <a:blip r:embed="rId2"/>
          <a:srcRect l="8612" t="50808" r="51319" b="31037"/>
          <a:stretch/>
        </p:blipFill>
        <p:spPr>
          <a:xfrm>
            <a:off x="522360" y="4643280"/>
            <a:ext cx="6146640" cy="168444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3" descr=""/>
          <p:cNvPicPr/>
          <p:nvPr/>
        </p:nvPicPr>
        <p:blipFill>
          <a:blip r:embed="rId3"/>
          <a:srcRect l="0" t="0" r="48070" b="0"/>
          <a:stretch/>
        </p:blipFill>
        <p:spPr>
          <a:xfrm>
            <a:off x="798480" y="7081920"/>
            <a:ext cx="5492880" cy="1177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1-13T13:31:02Z</dcterms:created>
  <dc:creator>Adam Hall</dc:creator>
  <dc:description/>
  <dc:language>en-US</dc:language>
  <cp:lastModifiedBy>l.latha</cp:lastModifiedBy>
  <dcterms:modified xsi:type="dcterms:W3CDTF">2016-04-05T12:11:46Z</dcterms:modified>
  <cp:revision>14</cp:revision>
  <dc:subject/>
  <dc:title>PowerPoint Presentation</dc:title>
</cp:coreProperties>
</file>